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421655816" name="Lis" initials="L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434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.tiff"/><Relationship Id="rId1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7882890" y="860425"/>
            <a:ext cx="390398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 S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Multiple sequence alignment of NhHO1 with ApHO1. The HemeO was marked with red line.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CD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98755" y="338455"/>
            <a:ext cx="7461885" cy="61595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5" name="组合 24"/>
          <p:cNvGrpSpPr/>
          <p:nvPr/>
        </p:nvGrpSpPr>
        <p:grpSpPr>
          <a:xfrm>
            <a:off x="500380" y="781685"/>
            <a:ext cx="6346190" cy="4739005"/>
            <a:chOff x="3903" y="1844"/>
            <a:chExt cx="9994" cy="7463"/>
          </a:xfrm>
        </p:grpSpPr>
        <p:pic>
          <p:nvPicPr>
            <p:cNvPr id="167938" name="图片 1" descr="20240606-His-1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903" y="1844"/>
              <a:ext cx="9994" cy="7463"/>
            </a:xfrm>
            <a:prstGeom prst="rect">
              <a:avLst/>
            </a:prstGeom>
            <a:noFill/>
            <a:ln w="9525">
              <a:noFill/>
            </a:ln>
          </p:spPr>
        </p:pic>
        <p:cxnSp>
          <p:nvCxnSpPr>
            <p:cNvPr id="9" name="直接箭头连接符 8"/>
            <p:cNvCxnSpPr/>
            <p:nvPr/>
          </p:nvCxnSpPr>
          <p:spPr>
            <a:xfrm flipV="1">
              <a:off x="7611" y="6376"/>
              <a:ext cx="16" cy="381"/>
            </a:xfrm>
            <a:prstGeom prst="straightConnector1">
              <a:avLst/>
            </a:prstGeom>
            <a:ln>
              <a:solidFill>
                <a:srgbClr val="C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/>
          </p:nvSpPr>
          <p:spPr>
            <a:xfrm>
              <a:off x="7189" y="6857"/>
              <a:ext cx="860" cy="3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800">
                  <a:solidFill>
                    <a:srgbClr val="C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NhHO1</a:t>
              </a:r>
              <a:endPara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12" name="直接箭头连接符 11"/>
            <p:cNvCxnSpPr/>
            <p:nvPr/>
          </p:nvCxnSpPr>
          <p:spPr>
            <a:xfrm flipV="1">
              <a:off x="8233" y="6171"/>
              <a:ext cx="16" cy="381"/>
            </a:xfrm>
            <a:prstGeom prst="straightConnector1">
              <a:avLst/>
            </a:prstGeom>
            <a:ln>
              <a:solidFill>
                <a:srgbClr val="C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3" name="文本框 12"/>
            <p:cNvSpPr txBox="1"/>
            <p:nvPr/>
          </p:nvSpPr>
          <p:spPr>
            <a:xfrm>
              <a:off x="7811" y="6652"/>
              <a:ext cx="860" cy="3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800">
                  <a:solidFill>
                    <a:srgbClr val="C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ApHO1</a:t>
              </a:r>
              <a:endPara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14" name="直接箭头连接符 13"/>
            <p:cNvCxnSpPr/>
            <p:nvPr/>
          </p:nvCxnSpPr>
          <p:spPr>
            <a:xfrm flipV="1">
              <a:off x="9677" y="6171"/>
              <a:ext cx="16" cy="381"/>
            </a:xfrm>
            <a:prstGeom prst="straightConnector1">
              <a:avLst/>
            </a:prstGeom>
            <a:ln>
              <a:solidFill>
                <a:srgbClr val="C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9255" y="6652"/>
              <a:ext cx="860" cy="3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800">
                  <a:solidFill>
                    <a:srgbClr val="C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ApHO1</a:t>
              </a:r>
              <a:endPara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16" name="直接箭头连接符 15"/>
            <p:cNvCxnSpPr/>
            <p:nvPr/>
          </p:nvCxnSpPr>
          <p:spPr>
            <a:xfrm flipV="1">
              <a:off x="10404" y="6171"/>
              <a:ext cx="16" cy="381"/>
            </a:xfrm>
            <a:prstGeom prst="straightConnector1">
              <a:avLst/>
            </a:prstGeom>
            <a:ln>
              <a:solidFill>
                <a:srgbClr val="C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7" name="文本框 16"/>
            <p:cNvSpPr txBox="1"/>
            <p:nvPr/>
          </p:nvSpPr>
          <p:spPr>
            <a:xfrm>
              <a:off x="9982" y="6652"/>
              <a:ext cx="860" cy="3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800">
                  <a:solidFill>
                    <a:srgbClr val="C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ApHO1</a:t>
              </a:r>
              <a:endPara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18" name="直接箭头连接符 17"/>
            <p:cNvCxnSpPr>
              <a:stCxn id="21" idx="1"/>
            </p:cNvCxnSpPr>
            <p:nvPr/>
          </p:nvCxnSpPr>
          <p:spPr>
            <a:xfrm flipH="1">
              <a:off x="10527" y="5872"/>
              <a:ext cx="487" cy="123"/>
            </a:xfrm>
            <a:prstGeom prst="straightConnector1">
              <a:avLst/>
            </a:prstGeom>
            <a:ln>
              <a:solidFill>
                <a:srgbClr val="C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11014" y="5672"/>
              <a:ext cx="1091" cy="3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800">
                  <a:solidFill>
                    <a:srgbClr val="C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NHpebA</a:t>
              </a:r>
              <a:endPara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22" name="直接箭头连接符 21"/>
            <p:cNvCxnSpPr/>
            <p:nvPr/>
          </p:nvCxnSpPr>
          <p:spPr>
            <a:xfrm flipV="1">
              <a:off x="11003" y="6171"/>
              <a:ext cx="16" cy="381"/>
            </a:xfrm>
            <a:prstGeom prst="straightConnector1">
              <a:avLst/>
            </a:prstGeom>
            <a:ln>
              <a:solidFill>
                <a:srgbClr val="C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23" name="文本框 22"/>
            <p:cNvSpPr txBox="1"/>
            <p:nvPr/>
          </p:nvSpPr>
          <p:spPr>
            <a:xfrm>
              <a:off x="10581" y="6652"/>
              <a:ext cx="860" cy="3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800">
                  <a:solidFill>
                    <a:srgbClr val="C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ApHO1</a:t>
              </a:r>
              <a:endPara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6914" name="文本框 2"/>
            <p:cNvSpPr txBox="1"/>
            <p:nvPr/>
          </p:nvSpPr>
          <p:spPr>
            <a:xfrm>
              <a:off x="6328" y="2309"/>
              <a:ext cx="5803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M   1    2     3       M   4    5      6 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  <p:sp>
          <p:nvSpPr>
            <p:cNvPr id="168964" name="文本框 2"/>
            <p:cNvSpPr txBox="1"/>
            <p:nvPr/>
          </p:nvSpPr>
          <p:spPr>
            <a:xfrm>
              <a:off x="4880" y="2192"/>
              <a:ext cx="1288" cy="52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noAutofit/>
            </a:bodyPr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KDa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20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80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60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50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40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30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algn="r"/>
              <a:r>
                <a:rPr lang="en-US" altLang="zh-CN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20</a:t>
              </a:r>
              <a:endPara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pic>
        <p:nvPicPr>
          <p:cNvPr id="27" name="图片 1" descr="20240620-S"/>
          <p:cNvPicPr>
            <a:picLocks noChangeAspect="1"/>
          </p:cNvPicPr>
          <p:nvPr/>
        </p:nvPicPr>
        <p:blipFill>
          <a:blip r:embed="rId2"/>
          <a:srcRect r="45986"/>
          <a:stretch>
            <a:fillRect/>
          </a:stretch>
        </p:blipFill>
        <p:spPr>
          <a:xfrm>
            <a:off x="6499860" y="1076960"/>
            <a:ext cx="3323590" cy="458660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8" name="文本框 2"/>
          <p:cNvSpPr txBox="1"/>
          <p:nvPr/>
        </p:nvSpPr>
        <p:spPr>
          <a:xfrm>
            <a:off x="7011670" y="1076960"/>
            <a:ext cx="817880" cy="33274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noAutofit/>
          </a:bodyPr>
          <a:p>
            <a:pPr algn="r"/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KDa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120</a:t>
            </a:r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80</a:t>
            </a:r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</a:t>
            </a:r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50</a:t>
            </a:r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40</a:t>
            </a:r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30</a:t>
            </a:r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20</a:t>
            </a:r>
            <a:endParaRPr lang="en-US" altLang="zh-CN" sz="14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9" name="文本框 2"/>
          <p:cNvSpPr txBox="1"/>
          <p:nvPr/>
        </p:nvSpPr>
        <p:spPr>
          <a:xfrm>
            <a:off x="7994650" y="1076960"/>
            <a:ext cx="14763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  1    2     3       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cxnSp>
        <p:nvCxnSpPr>
          <p:cNvPr id="30" name="直接箭头连接符 29"/>
          <p:cNvCxnSpPr/>
          <p:nvPr/>
        </p:nvCxnSpPr>
        <p:spPr>
          <a:xfrm flipV="1">
            <a:off x="8727440" y="3272155"/>
            <a:ext cx="10160" cy="241935"/>
          </a:xfrm>
          <a:prstGeom prst="straightConnector1">
            <a:avLst/>
          </a:prstGeom>
          <a:ln>
            <a:solidFill>
              <a:srgbClr val="C0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8459470" y="3577590"/>
            <a:ext cx="546100" cy="193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rPr>
              <a:t>NhpebB</a:t>
            </a:r>
            <a:endParaRPr lang="en-US" altLang="zh-CN" sz="800">
              <a:solidFill>
                <a:srgbClr val="C0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32" name="直接箭头连接符 31"/>
          <p:cNvCxnSpPr/>
          <p:nvPr/>
        </p:nvCxnSpPr>
        <p:spPr>
          <a:xfrm flipV="1">
            <a:off x="9132570" y="3272155"/>
            <a:ext cx="10160" cy="241935"/>
          </a:xfrm>
          <a:prstGeom prst="straightConnector1">
            <a:avLst/>
          </a:prstGeom>
          <a:ln>
            <a:solidFill>
              <a:srgbClr val="C0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8864600" y="3577590"/>
            <a:ext cx="546100" cy="193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800">
                <a:solidFill>
                  <a:srgbClr val="C00000"/>
                </a:solidFill>
                <a:latin typeface="Times New Roman" panose="02020603050405020304" charset="0"/>
                <a:cs typeface="Times New Roman" panose="02020603050405020304" charset="0"/>
              </a:rPr>
              <a:t>pebS</a:t>
            </a:r>
            <a:endParaRPr lang="en-US" altLang="zh-CN" sz="800">
              <a:solidFill>
                <a:srgbClr val="C0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647065" y="1002665"/>
            <a:ext cx="47371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3200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sz="32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6475095" y="1002665"/>
            <a:ext cx="47371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3200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 sz="32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816610" y="4731385"/>
            <a:ext cx="10865485" cy="181483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 S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. Original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Western blot results of recombinant NhHO1, ApHO1, NhPebA, NhPebB and PebS.</a:t>
            </a:r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  </a:t>
            </a:r>
            <a:endParaRPr lang="zh-CN" altLang="en-US" sz="16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(a) Western blot results of recombinant NhHO1, ApHO1 and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  <a:sym typeface="+mn-ea"/>
              </a:rPr>
              <a:t>NhPebA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, M: protein ladder, Lane 1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BL21 (petDuet-</a:t>
            </a:r>
            <a:r>
              <a:rPr lang="en-US" altLang="en-US" sz="1600">
                <a:latin typeface="Times New Roman" panose="02020603050405020304" charset="0"/>
                <a:cs typeface="Times New Roman" panose="02020603050405020304" charset="0"/>
              </a:rPr>
              <a:t>Ⅰ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), Lane 2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BL21 (pED-NhHO1), Lane 3 and 4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BL21 (pED-ApHO1), Lane 5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BL21 (pED-ApHO1 &amp; pRD-NhPebA-NhPebB), Lane 6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BL21 (pED-ApHO1-PebS). (b) Western blot results of recombinant NhPebB and PebS, M: protein ladder, Lane 1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BL21 (pED-ApHO1), Lane 2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BL21 (pED-ApHO1 &amp; pRD-NhPebA-NhPebB), Lane 3: crude enzyme extracted from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E. coli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BL21 (pED-ApHO1-PebS).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jM3MTQ4MGJjOTZlNjQzZTNhMzM2MDdjMWJhODk5M2Q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4</Words>
  <Application>WPS 演示</Application>
  <PresentationFormat>宽屏</PresentationFormat>
  <Paragraphs>5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uang L</dc:creator>
  <cp:lastModifiedBy>Lis</cp:lastModifiedBy>
  <cp:revision>25</cp:revision>
  <dcterms:created xsi:type="dcterms:W3CDTF">2023-08-09T12:44:00Z</dcterms:created>
  <dcterms:modified xsi:type="dcterms:W3CDTF">2025-07-12T14:06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1915</vt:lpwstr>
  </property>
</Properties>
</file>